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>
        <p:scale>
          <a:sx n="150" d="100"/>
          <a:sy n="150" d="100"/>
        </p:scale>
        <p:origin x="-1176" y="-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57B1C1-36C3-4FDC-AE0C-F41158AA654E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62F9FC-2C79-468E-A7F6-5ACD691932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7644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7901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4412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974185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412800" y="784800"/>
            <a:ext cx="11222400" cy="511200"/>
          </a:xfrm>
        </p:spPr>
        <p:txBody>
          <a:bodyPr/>
          <a:lstStyle>
            <a:lvl1pPr marL="0" indent="0">
              <a:buNone/>
              <a:defRPr sz="2079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/>
              <a:t>Click to add Secondary title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412801" y="1760401"/>
            <a:ext cx="8942399" cy="4424400"/>
          </a:xfrm>
        </p:spPr>
        <p:txBody>
          <a:bodyPr/>
          <a:lstStyle>
            <a:lvl1pPr marL="0" indent="0">
              <a:buNone/>
              <a:defRPr sz="1782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/>
              <a:t>Author | 00 Month Year</a:t>
            </a:r>
            <a:endParaRPr lang="sv-SE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/>
              <a:t>Set area descriptor | Sub level 1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271718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710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54880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52964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9440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3454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2809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57173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6004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60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13" Type="http://schemas.openxmlformats.org/officeDocument/2006/relationships/image" Target="../media/image17.png"/><Relationship Id="rId18" Type="http://schemas.openxmlformats.org/officeDocument/2006/relationships/image" Target="../media/image5.emf"/><Relationship Id="rId26" Type="http://schemas.openxmlformats.org/officeDocument/2006/relationships/image" Target="../media/image8.emf"/><Relationship Id="rId39" Type="http://schemas.openxmlformats.org/officeDocument/2006/relationships/oleObject" Target="../embeddings/oleObject12.bin"/><Relationship Id="rId3" Type="http://schemas.openxmlformats.org/officeDocument/2006/relationships/image" Target="../media/image13.png"/><Relationship Id="rId21" Type="http://schemas.openxmlformats.org/officeDocument/2006/relationships/image" Target="../media/image6.emf"/><Relationship Id="rId34" Type="http://schemas.openxmlformats.org/officeDocument/2006/relationships/oleObject" Target="../embeddings/oleObject10.bin"/><Relationship Id="rId42" Type="http://schemas.openxmlformats.org/officeDocument/2006/relationships/image" Target="../media/image28.png"/><Relationship Id="rId7" Type="http://schemas.openxmlformats.org/officeDocument/2006/relationships/oleObject" Target="../embeddings/oleObject1.bin"/><Relationship Id="rId12" Type="http://schemas.openxmlformats.org/officeDocument/2006/relationships/image" Target="../media/image3.emf"/><Relationship Id="rId17" Type="http://schemas.openxmlformats.org/officeDocument/2006/relationships/oleObject" Target="../embeddings/oleObject5.bin"/><Relationship Id="rId25" Type="http://schemas.openxmlformats.org/officeDocument/2006/relationships/oleObject" Target="../embeddings/oleObject8.bin"/><Relationship Id="rId33" Type="http://schemas.openxmlformats.org/officeDocument/2006/relationships/image" Target="../media/image25.png"/><Relationship Id="rId38" Type="http://schemas.openxmlformats.org/officeDocument/2006/relationships/image" Target="../media/image26.png"/><Relationship Id="rId2" Type="http://schemas.openxmlformats.org/officeDocument/2006/relationships/slideLayout" Target="../slideLayouts/slideLayout12.xml"/><Relationship Id="rId16" Type="http://schemas.openxmlformats.org/officeDocument/2006/relationships/image" Target="../media/image4.emf"/><Relationship Id="rId20" Type="http://schemas.openxmlformats.org/officeDocument/2006/relationships/oleObject" Target="../embeddings/oleObject6.bin"/><Relationship Id="rId29" Type="http://schemas.openxmlformats.org/officeDocument/2006/relationships/image" Target="../media/image23.png"/><Relationship Id="rId41" Type="http://schemas.openxmlformats.org/officeDocument/2006/relationships/image" Target="../media/image27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16.png"/><Relationship Id="rId11" Type="http://schemas.openxmlformats.org/officeDocument/2006/relationships/oleObject" Target="../embeddings/oleObject3.bin"/><Relationship Id="rId24" Type="http://schemas.openxmlformats.org/officeDocument/2006/relationships/image" Target="../media/image7.emf"/><Relationship Id="rId32" Type="http://schemas.openxmlformats.org/officeDocument/2006/relationships/image" Target="../media/image9.emf"/><Relationship Id="rId37" Type="http://schemas.openxmlformats.org/officeDocument/2006/relationships/image" Target="../media/image11.emf"/><Relationship Id="rId40" Type="http://schemas.openxmlformats.org/officeDocument/2006/relationships/image" Target="../media/image12.emf"/><Relationship Id="rId5" Type="http://schemas.openxmlformats.org/officeDocument/2006/relationships/image" Target="../media/image15.png"/><Relationship Id="rId15" Type="http://schemas.openxmlformats.org/officeDocument/2006/relationships/oleObject" Target="../embeddings/oleObject4.bin"/><Relationship Id="rId23" Type="http://schemas.openxmlformats.org/officeDocument/2006/relationships/oleObject" Target="../embeddings/oleObject7.bin"/><Relationship Id="rId28" Type="http://schemas.openxmlformats.org/officeDocument/2006/relationships/image" Target="../media/image22.png"/><Relationship Id="rId36" Type="http://schemas.openxmlformats.org/officeDocument/2006/relationships/oleObject" Target="../embeddings/oleObject11.bin"/><Relationship Id="rId10" Type="http://schemas.openxmlformats.org/officeDocument/2006/relationships/image" Target="../media/image2.emf"/><Relationship Id="rId19" Type="http://schemas.openxmlformats.org/officeDocument/2006/relationships/image" Target="../media/image19.png"/><Relationship Id="rId31" Type="http://schemas.openxmlformats.org/officeDocument/2006/relationships/oleObject" Target="../embeddings/oleObject9.bin"/><Relationship Id="rId4" Type="http://schemas.openxmlformats.org/officeDocument/2006/relationships/image" Target="../media/image14.png"/><Relationship Id="rId9" Type="http://schemas.openxmlformats.org/officeDocument/2006/relationships/oleObject" Target="../embeddings/oleObject2.bin"/><Relationship Id="rId14" Type="http://schemas.openxmlformats.org/officeDocument/2006/relationships/image" Target="../media/image18.png"/><Relationship Id="rId22" Type="http://schemas.openxmlformats.org/officeDocument/2006/relationships/image" Target="../media/image20.png"/><Relationship Id="rId27" Type="http://schemas.openxmlformats.org/officeDocument/2006/relationships/image" Target="../media/image21.png"/><Relationship Id="rId30" Type="http://schemas.openxmlformats.org/officeDocument/2006/relationships/image" Target="../media/image24.png"/><Relationship Id="rId35" Type="http://schemas.openxmlformats.org/officeDocument/2006/relationships/image" Target="../media/image10.emf"/><Relationship Id="rId43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5845" y="1216750"/>
            <a:ext cx="734808" cy="110899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>
            <a:off x="1865415" y="1022966"/>
            <a:ext cx="332142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/>
              <a:t>PRC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745070" y="1169664"/>
            <a:ext cx="471604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 err="1"/>
              <a:t>Vinculin</a:t>
            </a:r>
            <a:r>
              <a:rPr lang="sv-SE" sz="625" b="1" dirty="0"/>
              <a:t> 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177666" y="906507"/>
            <a:ext cx="772969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/>
              <a:t>0             35         75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2412617" y="754952"/>
            <a:ext cx="474810" cy="1747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36" b="1" dirty="0" err="1"/>
              <a:t>TAA</a:t>
            </a:r>
            <a:r>
              <a:rPr lang="sv-SE" sz="536" b="1" dirty="0"/>
              <a:t> (</a:t>
            </a:r>
            <a:r>
              <a:rPr lang="sv-SE" sz="536" b="1" dirty="0" err="1"/>
              <a:t>mM</a:t>
            </a:r>
            <a:r>
              <a:rPr lang="sv-SE" sz="536" b="1" dirty="0"/>
              <a:t>)</a:t>
            </a: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1110" y="1056924"/>
            <a:ext cx="763399" cy="151903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7234" y="1937165"/>
            <a:ext cx="712830" cy="90021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1864692" y="1733085"/>
            <a:ext cx="383606" cy="1885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25" b="1" dirty="0"/>
              <a:t>PRC 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812681" y="1887513"/>
            <a:ext cx="471604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 err="1"/>
              <a:t>Vinculin</a:t>
            </a:r>
            <a:r>
              <a:rPr lang="sv-SE" sz="625" b="1" dirty="0"/>
              <a:t> 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183490" y="1635504"/>
            <a:ext cx="803425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/>
              <a:t>0          1        2        3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416595" y="1465576"/>
            <a:ext cx="511679" cy="1747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36" b="1" dirty="0" err="1"/>
              <a:t>TASO</a:t>
            </a:r>
            <a:r>
              <a:rPr lang="sv-SE" sz="536" b="1" dirty="0"/>
              <a:t> (</a:t>
            </a:r>
            <a:r>
              <a:rPr lang="sv-SE" sz="536" b="1" dirty="0" err="1"/>
              <a:t>mM</a:t>
            </a:r>
            <a:r>
              <a:rPr lang="sv-SE" sz="536" b="1" dirty="0"/>
              <a:t>)</a:t>
            </a:r>
          </a:p>
        </p:txBody>
      </p:sp>
      <p:cxnSp>
        <p:nvCxnSpPr>
          <p:cNvPr id="89" name="Straight Connector 88"/>
          <p:cNvCxnSpPr/>
          <p:nvPr/>
        </p:nvCxnSpPr>
        <p:spPr>
          <a:xfrm>
            <a:off x="2368070" y="912751"/>
            <a:ext cx="492558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2400467" y="1635502"/>
            <a:ext cx="492558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1" name="Picture 9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77667" y="1766734"/>
            <a:ext cx="742399" cy="162863"/>
          </a:xfrm>
          <a:prstGeom prst="rect">
            <a:avLst/>
          </a:prstGeom>
        </p:spPr>
      </p:pic>
      <p:graphicFrame>
        <p:nvGraphicFramePr>
          <p:cNvPr id="92" name="Object 9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831255"/>
              </p:ext>
            </p:extLst>
          </p:nvPr>
        </p:nvGraphicFramePr>
        <p:xfrm>
          <a:off x="3027703" y="1557624"/>
          <a:ext cx="966534" cy="8153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6" name="Prism 6" r:id="rId7" imgW="3027661" imgH="2555293" progId="Prism6.Document">
                  <p:embed/>
                </p:oleObj>
              </mc:Choice>
              <mc:Fallback>
                <p:oleObj name="Prism 6" r:id="rId7" imgW="3027661" imgH="255529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27703" y="1557624"/>
                        <a:ext cx="966534" cy="8153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3" name="Group 92"/>
          <p:cNvGrpSpPr/>
          <p:nvPr/>
        </p:nvGrpSpPr>
        <p:grpSpPr>
          <a:xfrm>
            <a:off x="3048129" y="710704"/>
            <a:ext cx="880879" cy="877034"/>
            <a:chOff x="6592239" y="124665"/>
            <a:chExt cx="2160850" cy="2132287"/>
          </a:xfrm>
        </p:grpSpPr>
        <p:graphicFrame>
          <p:nvGraphicFramePr>
            <p:cNvPr id="94" name="Object 9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59236914"/>
                </p:ext>
              </p:extLst>
            </p:nvPr>
          </p:nvGraphicFramePr>
          <p:xfrm>
            <a:off x="6592239" y="124665"/>
            <a:ext cx="2160850" cy="18252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27" name="Prism 6" r:id="rId9" imgW="3027661" imgH="2555293" progId="Prism6.Document">
                    <p:embed/>
                  </p:oleObj>
                </mc:Choice>
                <mc:Fallback>
                  <p:oleObj name="Prism 6" r:id="rId9" imgW="3027661" imgH="2555293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592239" y="124665"/>
                          <a:ext cx="2160850" cy="18252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95" name="Straight Connector 94"/>
            <p:cNvCxnSpPr/>
            <p:nvPr/>
          </p:nvCxnSpPr>
          <p:spPr>
            <a:xfrm>
              <a:off x="7559720" y="1844547"/>
              <a:ext cx="643753" cy="406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>
              <a:off x="7352072" y="1807983"/>
              <a:ext cx="1176532" cy="448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504" b="1" dirty="0" err="1"/>
                <a:t>TAA</a:t>
              </a:r>
              <a:r>
                <a:rPr lang="sv-SE" sz="504" b="1" dirty="0"/>
                <a:t> (</a:t>
              </a:r>
              <a:r>
                <a:rPr lang="sv-SE" sz="600" b="1" dirty="0" err="1"/>
                <a:t>mM</a:t>
              </a:r>
              <a:r>
                <a:rPr lang="sv-SE" sz="504" b="1" dirty="0"/>
                <a:t>)</a:t>
              </a: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1801479" y="4036208"/>
            <a:ext cx="571707" cy="174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536" b="1" dirty="0"/>
              <a:t>Oligomycin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226739" y="4019406"/>
            <a:ext cx="935124" cy="202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14" b="1" dirty="0"/>
              <a:t>-       +         -       + 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1923899" y="3769033"/>
            <a:ext cx="374628" cy="1885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25" b="1" dirty="0"/>
              <a:t>PRC </a:t>
            </a:r>
          </a:p>
        </p:txBody>
      </p:sp>
      <p:graphicFrame>
        <p:nvGraphicFramePr>
          <p:cNvPr id="100" name="Object 9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9596808"/>
              </p:ext>
            </p:extLst>
          </p:nvPr>
        </p:nvGraphicFramePr>
        <p:xfrm>
          <a:off x="3062570" y="3642699"/>
          <a:ext cx="957888" cy="808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8" name="Prism 6" r:id="rId11" imgW="2986605" imgH="2518557" progId="Prism6.Document">
                  <p:embed/>
                </p:oleObj>
              </mc:Choice>
              <mc:Fallback>
                <p:oleObj name="Prism 6" r:id="rId11" imgW="2986605" imgH="251855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062570" y="3642699"/>
                        <a:ext cx="957888" cy="808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1" name="Picture 10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64460" y="3803503"/>
            <a:ext cx="908505" cy="101694"/>
          </a:xfrm>
          <a:prstGeom prst="rect">
            <a:avLst/>
          </a:prstGeom>
        </p:spPr>
      </p:pic>
      <p:pic>
        <p:nvPicPr>
          <p:cNvPr id="102" name="Picture 10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170283" y="3937257"/>
            <a:ext cx="915882" cy="132241"/>
          </a:xfrm>
          <a:prstGeom prst="rect">
            <a:avLst/>
          </a:prstGeom>
        </p:spPr>
      </p:pic>
      <p:sp>
        <p:nvSpPr>
          <p:cNvPr id="103" name="TextBox 102"/>
          <p:cNvSpPr txBox="1"/>
          <p:nvPr/>
        </p:nvSpPr>
        <p:spPr>
          <a:xfrm>
            <a:off x="1818884" y="3904141"/>
            <a:ext cx="531929" cy="1885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25" b="1" dirty="0" err="1"/>
              <a:t>Vinculin</a:t>
            </a:r>
            <a:r>
              <a:rPr lang="sv-SE" sz="625" b="1" dirty="0"/>
              <a:t> 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853088" y="729192"/>
            <a:ext cx="268022" cy="2571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71" b="1" dirty="0"/>
              <a:t>A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1856307" y="1418272"/>
            <a:ext cx="267014" cy="2571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71" b="1" dirty="0"/>
              <a:t>B</a:t>
            </a:r>
          </a:p>
        </p:txBody>
      </p:sp>
      <p:grpSp>
        <p:nvGrpSpPr>
          <p:cNvPr id="106" name="Group 105"/>
          <p:cNvGrpSpPr/>
          <p:nvPr/>
        </p:nvGrpSpPr>
        <p:grpSpPr>
          <a:xfrm>
            <a:off x="1951828" y="2162064"/>
            <a:ext cx="1200970" cy="385356"/>
            <a:chOff x="-4927724" y="1475711"/>
            <a:chExt cx="2690075" cy="863165"/>
          </a:xfrm>
        </p:grpSpPr>
        <p:sp>
          <p:nvSpPr>
            <p:cNvPr id="107" name="TextBox 106"/>
            <p:cNvSpPr txBox="1"/>
            <p:nvPr/>
          </p:nvSpPr>
          <p:spPr>
            <a:xfrm>
              <a:off x="-4927724" y="1694020"/>
              <a:ext cx="2690075" cy="422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25" b="1" dirty="0"/>
                <a:t>CH</a:t>
              </a:r>
              <a:r>
                <a:rPr lang="sv-SE" sz="625" b="1" baseline="-25000" dirty="0"/>
                <a:t>3</a:t>
              </a:r>
              <a:r>
                <a:rPr lang="sv-SE" sz="625" b="1" dirty="0"/>
                <a:t>CSNH</a:t>
              </a:r>
              <a:r>
                <a:rPr lang="sv-SE" sz="625" b="1" baseline="-25000" dirty="0"/>
                <a:t>2               </a:t>
              </a:r>
              <a:r>
                <a:rPr lang="sv-SE" sz="625" b="1" dirty="0"/>
                <a:t>      CH</a:t>
              </a:r>
              <a:r>
                <a:rPr lang="sv-SE" sz="625" b="1" baseline="-25000" dirty="0"/>
                <a:t>3</a:t>
              </a:r>
              <a:r>
                <a:rPr lang="sv-SE" sz="625" b="1" dirty="0"/>
                <a:t>CSONH</a:t>
              </a:r>
              <a:r>
                <a:rPr lang="sv-SE" sz="625" b="1" baseline="-25000" dirty="0"/>
                <a:t>2</a:t>
              </a:r>
            </a:p>
          </p:txBody>
        </p:sp>
        <p:sp>
          <p:nvSpPr>
            <p:cNvPr id="108" name="Right Arrow 107"/>
            <p:cNvSpPr/>
            <p:nvPr/>
          </p:nvSpPr>
          <p:spPr>
            <a:xfrm>
              <a:off x="-3903216" y="1810663"/>
              <a:ext cx="351606" cy="29607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536" b="1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-4164091" y="1475711"/>
              <a:ext cx="1063536" cy="459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33" b="1" dirty="0"/>
                <a:t>CYP2E1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-4788168" y="1903894"/>
              <a:ext cx="873232" cy="422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25" b="1" dirty="0"/>
                <a:t>(</a:t>
              </a:r>
              <a:r>
                <a:rPr lang="sv-SE" sz="625" b="1" dirty="0" err="1"/>
                <a:t>TAA</a:t>
              </a:r>
              <a:r>
                <a:rPr lang="sv-SE" sz="625" b="1" dirty="0"/>
                <a:t>) 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-3366449" y="1916623"/>
              <a:ext cx="973769" cy="422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25" b="1" dirty="0"/>
                <a:t>(</a:t>
              </a:r>
              <a:r>
                <a:rPr lang="sv-SE" sz="625" b="1" dirty="0" err="1"/>
                <a:t>TASO</a:t>
              </a:r>
              <a:r>
                <a:rPr lang="sv-SE" sz="625" b="1" dirty="0"/>
                <a:t>) </a:t>
              </a:r>
            </a:p>
          </p:txBody>
        </p:sp>
      </p:grpSp>
      <p:sp>
        <p:nvSpPr>
          <p:cNvPr id="112" name="TextBox 111"/>
          <p:cNvSpPr txBox="1"/>
          <p:nvPr/>
        </p:nvSpPr>
        <p:spPr>
          <a:xfrm>
            <a:off x="1847534" y="2105159"/>
            <a:ext cx="256802" cy="2571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71" b="1" dirty="0"/>
              <a:t>C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1822293" y="3585944"/>
            <a:ext cx="170826" cy="2571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71" b="1" dirty="0"/>
              <a:t>E</a:t>
            </a:r>
          </a:p>
        </p:txBody>
      </p:sp>
      <p:graphicFrame>
        <p:nvGraphicFramePr>
          <p:cNvPr id="114" name="Object 1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0281321"/>
              </p:ext>
            </p:extLst>
          </p:nvPr>
        </p:nvGraphicFramePr>
        <p:xfrm>
          <a:off x="2010844" y="2651710"/>
          <a:ext cx="909220" cy="9153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9" name="Prism 6" r:id="rId15" imgW="2671127" imgH="2689630" progId="Prism6.Document">
                  <p:embed/>
                </p:oleObj>
              </mc:Choice>
              <mc:Fallback>
                <p:oleObj name="Prism 6" r:id="rId15" imgW="2671127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10844" y="2651710"/>
                        <a:ext cx="909220" cy="9153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5" name="Object 1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4306006"/>
              </p:ext>
            </p:extLst>
          </p:nvPr>
        </p:nvGraphicFramePr>
        <p:xfrm>
          <a:off x="2826515" y="2655715"/>
          <a:ext cx="936977" cy="9153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0" name="Prism 6" r:id="rId17" imgW="2753238" imgH="2689630" progId="Prism6.Document">
                  <p:embed/>
                </p:oleObj>
              </mc:Choice>
              <mc:Fallback>
                <p:oleObj name="Prism 6" r:id="rId17" imgW="2753238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826515" y="2655715"/>
                        <a:ext cx="936977" cy="9153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TextBox 115"/>
          <p:cNvSpPr txBox="1"/>
          <p:nvPr/>
        </p:nvSpPr>
        <p:spPr>
          <a:xfrm>
            <a:off x="1840019" y="2655406"/>
            <a:ext cx="191467" cy="2571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71" b="1" dirty="0"/>
              <a:t>D</a:t>
            </a:r>
          </a:p>
        </p:txBody>
      </p:sp>
      <p:cxnSp>
        <p:nvCxnSpPr>
          <p:cNvPr id="117" name="Straight Connector 116"/>
          <p:cNvCxnSpPr/>
          <p:nvPr/>
        </p:nvCxnSpPr>
        <p:spPr>
          <a:xfrm flipV="1">
            <a:off x="3237792" y="3481687"/>
            <a:ext cx="292829" cy="14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3138236" y="3467378"/>
            <a:ext cx="753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00" b="1" dirty="0" err="1"/>
              <a:t>TASO</a:t>
            </a:r>
            <a:r>
              <a:rPr lang="sv-SE" sz="600" b="1" dirty="0"/>
              <a:t> (</a:t>
            </a:r>
            <a:r>
              <a:rPr lang="sv-SE" sz="600" b="1" dirty="0" err="1"/>
              <a:t>mM</a:t>
            </a:r>
            <a:r>
              <a:rPr lang="sv-SE" sz="600" b="1" dirty="0"/>
              <a:t>)</a:t>
            </a:r>
          </a:p>
        </p:txBody>
      </p:sp>
      <p:cxnSp>
        <p:nvCxnSpPr>
          <p:cNvPr id="119" name="Straight Connector 118"/>
          <p:cNvCxnSpPr/>
          <p:nvPr/>
        </p:nvCxnSpPr>
        <p:spPr>
          <a:xfrm>
            <a:off x="3438121" y="2347170"/>
            <a:ext cx="294966" cy="186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3305584" y="2348523"/>
            <a:ext cx="5852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00" b="1" dirty="0" err="1"/>
              <a:t>TASO</a:t>
            </a:r>
            <a:r>
              <a:rPr lang="sv-SE" sz="504" b="1" dirty="0"/>
              <a:t> (</a:t>
            </a:r>
            <a:r>
              <a:rPr lang="sv-SE" sz="504" b="1" dirty="0" err="1"/>
              <a:t>mM</a:t>
            </a:r>
            <a:r>
              <a:rPr lang="sv-SE" sz="504" b="1" dirty="0"/>
              <a:t>)</a:t>
            </a:r>
          </a:p>
        </p:txBody>
      </p:sp>
      <p:cxnSp>
        <p:nvCxnSpPr>
          <p:cNvPr id="121" name="Straight Connector 120"/>
          <p:cNvCxnSpPr/>
          <p:nvPr/>
        </p:nvCxnSpPr>
        <p:spPr>
          <a:xfrm flipV="1">
            <a:off x="2387271" y="3482080"/>
            <a:ext cx="292829" cy="14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2314501" y="3484208"/>
            <a:ext cx="729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00" b="1" dirty="0" err="1"/>
              <a:t>TASO</a:t>
            </a:r>
            <a:r>
              <a:rPr lang="sv-SE" sz="600" b="1" dirty="0"/>
              <a:t> (</a:t>
            </a:r>
            <a:r>
              <a:rPr lang="sv-SE" sz="600" b="1" dirty="0" err="1"/>
              <a:t>mM</a:t>
            </a:r>
            <a:r>
              <a:rPr lang="sv-SE" sz="600" b="1" dirty="0"/>
              <a:t>)</a:t>
            </a:r>
          </a:p>
        </p:txBody>
      </p:sp>
      <p:grpSp>
        <p:nvGrpSpPr>
          <p:cNvPr id="123" name="Group 122"/>
          <p:cNvGrpSpPr/>
          <p:nvPr/>
        </p:nvGrpSpPr>
        <p:grpSpPr>
          <a:xfrm>
            <a:off x="4952062" y="1567894"/>
            <a:ext cx="1715055" cy="1977006"/>
            <a:chOff x="245921" y="2357039"/>
            <a:chExt cx="3884844" cy="4178747"/>
          </a:xfrm>
        </p:grpSpPr>
        <p:pic>
          <p:nvPicPr>
            <p:cNvPr id="124" name="Picture 4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437872" y="2514440"/>
              <a:ext cx="1876439" cy="20323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5" name="TextBox 124"/>
            <p:cNvSpPr txBox="1"/>
            <p:nvPr/>
          </p:nvSpPr>
          <p:spPr>
            <a:xfrm>
              <a:off x="601535" y="2607858"/>
              <a:ext cx="857651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CD86</a:t>
              </a:r>
            </a:p>
          </p:txBody>
        </p:sp>
        <p:grpSp>
          <p:nvGrpSpPr>
            <p:cNvPr id="126" name="Group 58"/>
            <p:cNvGrpSpPr/>
            <p:nvPr/>
          </p:nvGrpSpPr>
          <p:grpSpPr>
            <a:xfrm>
              <a:off x="2161044" y="2502896"/>
              <a:ext cx="1924050" cy="2080227"/>
              <a:chOff x="2443922" y="693969"/>
              <a:chExt cx="1924050" cy="2080227"/>
            </a:xfrm>
          </p:grpSpPr>
          <p:grpSp>
            <p:nvGrpSpPr>
              <p:cNvPr id="145" name="Group 16"/>
              <p:cNvGrpSpPr/>
              <p:nvPr/>
            </p:nvGrpSpPr>
            <p:grpSpPr>
              <a:xfrm>
                <a:off x="2443922" y="776231"/>
                <a:ext cx="1924050" cy="1997965"/>
                <a:chOff x="1795639" y="-60481"/>
                <a:chExt cx="1924050" cy="1997965"/>
              </a:xfrm>
            </p:grpSpPr>
            <p:graphicFrame>
              <p:nvGraphicFramePr>
                <p:cNvPr id="147" name="Object 146"/>
                <p:cNvGraphicFramePr>
                  <a:graphicFrameLocks noChangeAspect="1"/>
                </p:cNvGraphicFramePr>
                <p:nvPr/>
              </p:nvGraphicFramePr>
              <p:xfrm>
                <a:off x="1795639" y="-60481"/>
                <a:ext cx="1924050" cy="1752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3331" name="Prism 6" r:id="rId20" imgW="2704619" imgH="2463814" progId="Prism6.Document">
                        <p:embed/>
                      </p:oleObj>
                    </mc:Choice>
                    <mc:Fallback>
                      <p:oleObj name="Prism 6" r:id="rId20" imgW="2704619" imgH="2463814" progId="Prism6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21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1795639" y="-60481"/>
                              <a:ext cx="1924050" cy="1752600"/>
                            </a:xfrm>
                            <a:prstGeom prst="rect">
                              <a:avLst/>
                            </a:prstGeom>
                            <a:noFill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148" name="Straight Connector 147"/>
                <p:cNvCxnSpPr/>
                <p:nvPr/>
              </p:nvCxnSpPr>
              <p:spPr bwMode="auto">
                <a:xfrm>
                  <a:off x="2733081" y="1599207"/>
                  <a:ext cx="703431" cy="0"/>
                </a:xfrm>
                <a:prstGeom prst="line">
                  <a:avLst/>
                </a:prstGeom>
                <a:solidFill>
                  <a:schemeClr val="accent1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49" name="TextBox 148"/>
                <p:cNvSpPr txBox="1"/>
                <p:nvPr/>
              </p:nvSpPr>
              <p:spPr>
                <a:xfrm>
                  <a:off x="2684510" y="1514633"/>
                  <a:ext cx="854017" cy="4228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700" b="1" dirty="0"/>
                    <a:t>CCCP</a:t>
                  </a:r>
                  <a:endParaRPr lang="sv-SE" sz="517" b="1" dirty="0"/>
                </a:p>
              </p:txBody>
            </p:sp>
          </p:grpSp>
          <p:sp>
            <p:nvSpPr>
              <p:cNvPr id="146" name="TextBox 145"/>
              <p:cNvSpPr txBox="1"/>
              <p:nvPr/>
            </p:nvSpPr>
            <p:spPr>
              <a:xfrm>
                <a:off x="2716206" y="693969"/>
                <a:ext cx="1282480" cy="422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700" b="1" dirty="0" err="1"/>
                  <a:t>MFI</a:t>
                </a:r>
                <a:r>
                  <a:rPr lang="sv-SE" sz="700" b="1" dirty="0"/>
                  <a:t>, CD86</a:t>
                </a:r>
              </a:p>
            </p:txBody>
          </p:sp>
        </p:grpSp>
        <p:sp>
          <p:nvSpPr>
            <p:cNvPr id="127" name="TextBox 126"/>
            <p:cNvSpPr txBox="1"/>
            <p:nvPr/>
          </p:nvSpPr>
          <p:spPr>
            <a:xfrm rot="16200000">
              <a:off x="54688" y="3551058"/>
              <a:ext cx="905333" cy="522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b="1" dirty="0"/>
                <a:t>CCCP</a:t>
              </a:r>
              <a:endParaRPr lang="sv-SE" sz="665" b="1" dirty="0"/>
            </a:p>
          </p:txBody>
        </p:sp>
        <p:pic>
          <p:nvPicPr>
            <p:cNvPr id="128" name="Picture 2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431143" y="4417116"/>
              <a:ext cx="1907531" cy="20660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9" name="TextBox 128"/>
            <p:cNvSpPr txBox="1"/>
            <p:nvPr/>
          </p:nvSpPr>
          <p:spPr>
            <a:xfrm>
              <a:off x="643277" y="4511461"/>
              <a:ext cx="857651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CD86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93768" y="4240148"/>
              <a:ext cx="1355101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Monocytes</a:t>
              </a:r>
              <a:endParaRPr lang="sv-SE" sz="700" b="1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714130" y="2357039"/>
              <a:ext cx="1631059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Dendritic</a:t>
              </a:r>
              <a:r>
                <a:rPr lang="sv-SE" sz="700" b="1" dirty="0"/>
                <a:t> Cells</a:t>
              </a:r>
            </a:p>
          </p:txBody>
        </p:sp>
        <p:graphicFrame>
          <p:nvGraphicFramePr>
            <p:cNvPr id="132" name="Object 131"/>
            <p:cNvGraphicFramePr>
              <a:graphicFrameLocks noChangeAspect="1"/>
            </p:cNvGraphicFramePr>
            <p:nvPr/>
          </p:nvGraphicFramePr>
          <p:xfrm>
            <a:off x="2206715" y="4546799"/>
            <a:ext cx="1924050" cy="1751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2" name="Prism 6" r:id="rId23" imgW="2704619" imgH="2463814" progId="Prism6.Document">
                    <p:embed/>
                  </p:oleObj>
                </mc:Choice>
                <mc:Fallback>
                  <p:oleObj name="Prism 6" r:id="rId23" imgW="2704619" imgH="2463814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06715" y="4546799"/>
                          <a:ext cx="1924050" cy="1751012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33" name="Straight Connector 132"/>
            <p:cNvCxnSpPr/>
            <p:nvPr/>
          </p:nvCxnSpPr>
          <p:spPr bwMode="auto">
            <a:xfrm>
              <a:off x="3057985" y="6193056"/>
              <a:ext cx="703431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34" name="TextBox 133"/>
            <p:cNvSpPr txBox="1"/>
            <p:nvPr/>
          </p:nvSpPr>
          <p:spPr>
            <a:xfrm>
              <a:off x="3039467" y="6112935"/>
              <a:ext cx="854018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CCCP</a:t>
              </a:r>
              <a:endParaRPr lang="sv-SE" sz="517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458911" y="4381698"/>
              <a:ext cx="1282481" cy="4228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MFI</a:t>
              </a:r>
              <a:r>
                <a:rPr lang="sv-SE" sz="700" b="1" dirty="0"/>
                <a:t>, CD86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620051" y="2963031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617309" y="3384740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1641888" y="3757421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  <a:p>
              <a:endParaRPr lang="sv-SE" sz="443" b="1" dirty="0">
                <a:solidFill>
                  <a:srgbClr val="FF0000"/>
                </a:solidFill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655618" y="4853706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655618" y="5343323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665763" y="5716787"/>
              <a:ext cx="930196" cy="6194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  <a:p>
              <a:endParaRPr lang="sv-SE" sz="443" b="1" dirty="0">
                <a:solidFill>
                  <a:srgbClr val="FF0000"/>
                </a:solidFill>
              </a:endParaRPr>
            </a:p>
          </p:txBody>
        </p:sp>
        <p:cxnSp>
          <p:nvCxnSpPr>
            <p:cNvPr id="142" name="Straight Connector 141"/>
            <p:cNvCxnSpPr/>
            <p:nvPr/>
          </p:nvCxnSpPr>
          <p:spPr bwMode="auto">
            <a:xfrm>
              <a:off x="743638" y="3550808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43" name="Straight Connector 142"/>
            <p:cNvCxnSpPr/>
            <p:nvPr/>
          </p:nvCxnSpPr>
          <p:spPr bwMode="auto">
            <a:xfrm>
              <a:off x="736241" y="5504285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44" name="TextBox 143"/>
            <p:cNvSpPr txBox="1"/>
            <p:nvPr/>
          </p:nvSpPr>
          <p:spPr>
            <a:xfrm rot="16200000">
              <a:off x="70059" y="5507321"/>
              <a:ext cx="905333" cy="5228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b="1" dirty="0"/>
                <a:t>CCCP</a:t>
              </a:r>
            </a:p>
          </p:txBody>
        </p:sp>
      </p:grpSp>
      <p:graphicFrame>
        <p:nvGraphicFramePr>
          <p:cNvPr id="150" name="Object 1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1976185"/>
              </p:ext>
            </p:extLst>
          </p:nvPr>
        </p:nvGraphicFramePr>
        <p:xfrm>
          <a:off x="6363339" y="575590"/>
          <a:ext cx="866779" cy="819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3" name="Prism 6" r:id="rId25" imgW="2904495" imgH="2747255" progId="Prism6.Document">
                  <p:embed/>
                </p:oleObj>
              </mc:Choice>
              <mc:Fallback>
                <p:oleObj name="Prism 6" r:id="rId25" imgW="2904495" imgH="274725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363339" y="575590"/>
                        <a:ext cx="866779" cy="8199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51" name="Straight Connector 150"/>
          <p:cNvCxnSpPr>
            <a:cxnSpLocks/>
          </p:cNvCxnSpPr>
          <p:nvPr/>
        </p:nvCxnSpPr>
        <p:spPr>
          <a:xfrm flipV="1">
            <a:off x="4933583" y="1060651"/>
            <a:ext cx="334366" cy="3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>
            <a:cxnSpLocks/>
          </p:cNvCxnSpPr>
          <p:nvPr/>
        </p:nvCxnSpPr>
        <p:spPr>
          <a:xfrm flipV="1">
            <a:off x="5465106" y="1055718"/>
            <a:ext cx="334366" cy="3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>
            <a:cxnSpLocks/>
          </p:cNvCxnSpPr>
          <p:nvPr/>
        </p:nvCxnSpPr>
        <p:spPr>
          <a:xfrm flipV="1">
            <a:off x="6003801" y="1057332"/>
            <a:ext cx="334366" cy="3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5460406" y="901776"/>
            <a:ext cx="4082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00" b="1" dirty="0" err="1"/>
              <a:t>esiGFP</a:t>
            </a:r>
            <a:endParaRPr lang="sv-SE" sz="7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5974529" y="898604"/>
            <a:ext cx="4565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00" b="1" dirty="0" err="1"/>
              <a:t>esiPRC</a:t>
            </a:r>
            <a:endParaRPr lang="sv-SE" sz="700" b="1" dirty="0"/>
          </a:p>
        </p:txBody>
      </p:sp>
      <p:cxnSp>
        <p:nvCxnSpPr>
          <p:cNvPr id="156" name="Straight Connector 155"/>
          <p:cNvCxnSpPr>
            <a:cxnSpLocks/>
          </p:cNvCxnSpPr>
          <p:nvPr/>
        </p:nvCxnSpPr>
        <p:spPr>
          <a:xfrm flipV="1">
            <a:off x="5551131" y="941758"/>
            <a:ext cx="651585" cy="3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5708599" y="781228"/>
            <a:ext cx="5924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00" b="1" dirty="0"/>
              <a:t>CCCP</a:t>
            </a:r>
          </a:p>
        </p:txBody>
      </p:sp>
      <p:cxnSp>
        <p:nvCxnSpPr>
          <p:cNvPr id="158" name="Straight Connector 157"/>
          <p:cNvCxnSpPr>
            <a:cxnSpLocks/>
          </p:cNvCxnSpPr>
          <p:nvPr/>
        </p:nvCxnSpPr>
        <p:spPr>
          <a:xfrm flipV="1">
            <a:off x="6727660" y="1377053"/>
            <a:ext cx="357537" cy="123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58"/>
          <p:cNvSpPr txBox="1"/>
          <p:nvPr/>
        </p:nvSpPr>
        <p:spPr>
          <a:xfrm>
            <a:off x="6737765" y="1385707"/>
            <a:ext cx="5091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00" b="1" dirty="0"/>
              <a:t>CCCP</a:t>
            </a:r>
            <a:endParaRPr lang="sv-SE" sz="800" b="1" dirty="0"/>
          </a:p>
        </p:txBody>
      </p:sp>
      <p:pic>
        <p:nvPicPr>
          <p:cNvPr id="160" name="Picture 159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881318" y="1237499"/>
            <a:ext cx="1558743" cy="62026"/>
          </a:xfrm>
          <a:prstGeom prst="rect">
            <a:avLst/>
          </a:prstGeom>
        </p:spPr>
      </p:pic>
      <p:pic>
        <p:nvPicPr>
          <p:cNvPr id="161" name="Picture 160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890920" y="1079486"/>
            <a:ext cx="1515672" cy="125085"/>
          </a:xfrm>
          <a:prstGeom prst="rect">
            <a:avLst/>
          </a:prstGeom>
        </p:spPr>
      </p:pic>
      <p:sp>
        <p:nvSpPr>
          <p:cNvPr id="162" name="TextBox 161"/>
          <p:cNvSpPr txBox="1"/>
          <p:nvPr/>
        </p:nvSpPr>
        <p:spPr>
          <a:xfrm>
            <a:off x="4927314" y="897429"/>
            <a:ext cx="4565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700" b="1" dirty="0" err="1"/>
              <a:t>esiGFP</a:t>
            </a:r>
            <a:endParaRPr lang="sv-SE" sz="7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4777397" y="743061"/>
            <a:ext cx="134178" cy="228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885" b="1" dirty="0"/>
              <a:t>G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4996965" y="1434222"/>
            <a:ext cx="136805" cy="228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885" b="1" dirty="0"/>
              <a:t>H</a:t>
            </a:r>
          </a:p>
        </p:txBody>
      </p:sp>
      <p:grpSp>
        <p:nvGrpSpPr>
          <p:cNvPr id="166" name="Group 165"/>
          <p:cNvGrpSpPr/>
          <p:nvPr/>
        </p:nvGrpSpPr>
        <p:grpSpPr>
          <a:xfrm>
            <a:off x="7464042" y="689251"/>
            <a:ext cx="3274620" cy="2119764"/>
            <a:chOff x="5908599" y="1154203"/>
            <a:chExt cx="7774105" cy="4575662"/>
          </a:xfrm>
        </p:grpSpPr>
        <p:pic>
          <p:nvPicPr>
            <p:cNvPr id="167" name="Picture 5"/>
            <p:cNvPicPr>
              <a:picLocks noChangeAspect="1"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9831401" y="1419184"/>
              <a:ext cx="2071598" cy="22437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68" name="Picture 3"/>
            <p:cNvPicPr>
              <a:picLocks noChangeAspect="1"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9837570" y="3452073"/>
              <a:ext cx="2100459" cy="21790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9" name="TextBox 168"/>
            <p:cNvSpPr txBox="1"/>
            <p:nvPr/>
          </p:nvSpPr>
          <p:spPr>
            <a:xfrm>
              <a:off x="10173196" y="3640118"/>
              <a:ext cx="83038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CD83</a:t>
              </a:r>
              <a:endParaRPr lang="sv-SE" sz="443" b="1" dirty="0"/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10143929" y="3271069"/>
              <a:ext cx="1481142" cy="4982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Monocytes</a:t>
              </a:r>
              <a:r>
                <a:rPr lang="sv-SE" sz="900" b="1" dirty="0"/>
                <a:t> </a:t>
              </a:r>
            </a:p>
          </p:txBody>
        </p:sp>
        <p:graphicFrame>
          <p:nvGraphicFramePr>
            <p:cNvPr id="171" name="Object 170"/>
            <p:cNvGraphicFramePr>
              <a:graphicFrameLocks noChangeAspect="1"/>
            </p:cNvGraphicFramePr>
            <p:nvPr/>
          </p:nvGraphicFramePr>
          <p:xfrm>
            <a:off x="11758654" y="3611732"/>
            <a:ext cx="1924050" cy="1751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4" name="Prism 6" r:id="rId31" imgW="2704619" imgH="2463814" progId="Prism6.Document">
                    <p:embed/>
                  </p:oleObj>
                </mc:Choice>
                <mc:Fallback>
                  <p:oleObj name="Prism 6" r:id="rId31" imgW="2704619" imgH="2463814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2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758654" y="3611732"/>
                          <a:ext cx="1924050" cy="175101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72" name="Straight Connector 171"/>
            <p:cNvCxnSpPr/>
            <p:nvPr/>
          </p:nvCxnSpPr>
          <p:spPr bwMode="auto">
            <a:xfrm>
              <a:off x="12620837" y="5283140"/>
              <a:ext cx="703431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73" name="TextBox 172"/>
            <p:cNvSpPr txBox="1"/>
            <p:nvPr/>
          </p:nvSpPr>
          <p:spPr>
            <a:xfrm>
              <a:off x="12540490" y="5296111"/>
              <a:ext cx="895078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CCCP</a:t>
              </a:r>
            </a:p>
          </p:txBody>
        </p:sp>
        <p:pic>
          <p:nvPicPr>
            <p:cNvPr id="174" name="Picture 3"/>
            <p:cNvPicPr>
              <a:picLocks noChangeAspect="1" noChangeArrowheads="1"/>
            </p:cNvPicPr>
            <p:nvPr/>
          </p:nvPicPr>
          <p:blipFill>
            <a:blip r:embed="rId33" cstate="print"/>
            <a:srcRect/>
            <a:stretch>
              <a:fillRect/>
            </a:stretch>
          </p:blipFill>
          <p:spPr bwMode="auto">
            <a:xfrm>
              <a:off x="6023804" y="3416922"/>
              <a:ext cx="2073750" cy="22460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75" name="TextBox 174"/>
            <p:cNvSpPr txBox="1"/>
            <p:nvPr/>
          </p:nvSpPr>
          <p:spPr>
            <a:xfrm>
              <a:off x="6303028" y="3620123"/>
              <a:ext cx="83038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CD83</a:t>
              </a:r>
              <a:endParaRPr lang="sv-SE" sz="443" b="1" dirty="0"/>
            </a:p>
          </p:txBody>
        </p:sp>
        <p:graphicFrame>
          <p:nvGraphicFramePr>
            <p:cNvPr id="176" name="Object 175"/>
            <p:cNvGraphicFramePr>
              <a:graphicFrameLocks noChangeAspect="1"/>
            </p:cNvGraphicFramePr>
            <p:nvPr/>
          </p:nvGraphicFramePr>
          <p:xfrm>
            <a:off x="7952423" y="3607140"/>
            <a:ext cx="1924050" cy="1747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5" name="Prism 6" r:id="rId34" imgW="2704619" imgH="2463814" progId="Prism6.Document">
                    <p:embed/>
                  </p:oleObj>
                </mc:Choice>
                <mc:Fallback>
                  <p:oleObj name="Prism 6" r:id="rId34" imgW="2704619" imgH="2463814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952423" y="3607140"/>
                          <a:ext cx="1924050" cy="1747837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77" name="Straight Connector 176"/>
            <p:cNvCxnSpPr/>
            <p:nvPr/>
          </p:nvCxnSpPr>
          <p:spPr bwMode="auto">
            <a:xfrm>
              <a:off x="8864461" y="5301696"/>
              <a:ext cx="703431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78" name="TextBox 177"/>
            <p:cNvSpPr txBox="1"/>
            <p:nvPr/>
          </p:nvSpPr>
          <p:spPr>
            <a:xfrm>
              <a:off x="8305675" y="5298032"/>
              <a:ext cx="1439281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Oligomycin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12135307" y="3683881"/>
              <a:ext cx="121094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MFI, CD83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8341640" y="3682456"/>
              <a:ext cx="121094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MFI, CD83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0181045" y="1631107"/>
              <a:ext cx="83038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CD83</a:t>
              </a:r>
              <a:endParaRPr lang="sv-SE" sz="443" b="1" dirty="0"/>
            </a:p>
          </p:txBody>
        </p:sp>
        <p:graphicFrame>
          <p:nvGraphicFramePr>
            <p:cNvPr id="182" name="Object 181"/>
            <p:cNvGraphicFramePr>
              <a:graphicFrameLocks noChangeAspect="1"/>
            </p:cNvGraphicFramePr>
            <p:nvPr/>
          </p:nvGraphicFramePr>
          <p:xfrm>
            <a:off x="11714389" y="1663089"/>
            <a:ext cx="1922462" cy="1752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6" name="Prism 6" r:id="rId36" imgW="2704619" imgH="2463814" progId="Prism6.Document">
                    <p:embed/>
                  </p:oleObj>
                </mc:Choice>
                <mc:Fallback>
                  <p:oleObj name="Prism 6" r:id="rId36" imgW="2704619" imgH="2463814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1714389" y="1663089"/>
                          <a:ext cx="1922462" cy="1752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3" name="Straight Connector 182"/>
            <p:cNvCxnSpPr/>
            <p:nvPr/>
          </p:nvCxnSpPr>
          <p:spPr bwMode="auto">
            <a:xfrm>
              <a:off x="12567864" y="3342233"/>
              <a:ext cx="703431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84" name="TextBox 183"/>
            <p:cNvSpPr txBox="1"/>
            <p:nvPr/>
          </p:nvSpPr>
          <p:spPr>
            <a:xfrm>
              <a:off x="12540490" y="3304285"/>
              <a:ext cx="895078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CCCP</a:t>
              </a: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2204083" y="1563710"/>
              <a:ext cx="121094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MFI, CD83</a:t>
              </a:r>
            </a:p>
          </p:txBody>
        </p:sp>
        <p:pic>
          <p:nvPicPr>
            <p:cNvPr id="186" name="Picture 3"/>
            <p:cNvPicPr>
              <a:picLocks noChangeAspect="1" noChangeArrowheads="1"/>
            </p:cNvPicPr>
            <p:nvPr/>
          </p:nvPicPr>
          <p:blipFill>
            <a:blip r:embed="rId38" cstate="print"/>
            <a:srcRect/>
            <a:stretch>
              <a:fillRect/>
            </a:stretch>
          </p:blipFill>
          <p:spPr bwMode="auto">
            <a:xfrm>
              <a:off x="6042746" y="1419184"/>
              <a:ext cx="2040441" cy="22099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aphicFrame>
          <p:nvGraphicFramePr>
            <p:cNvPr id="187" name="Object 186"/>
            <p:cNvGraphicFramePr>
              <a:graphicFrameLocks noChangeAspect="1"/>
            </p:cNvGraphicFramePr>
            <p:nvPr/>
          </p:nvGraphicFramePr>
          <p:xfrm>
            <a:off x="7919747" y="1657005"/>
            <a:ext cx="1922462" cy="1752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7" name="Prism 6" r:id="rId39" imgW="2704619" imgH="2463814" progId="Prism6.Document">
                    <p:embed/>
                  </p:oleObj>
                </mc:Choice>
                <mc:Fallback>
                  <p:oleObj name="Prism 6" r:id="rId39" imgW="2704619" imgH="2463814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0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919747" y="1657005"/>
                          <a:ext cx="1922462" cy="1752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8" name="Straight Connector 187"/>
            <p:cNvCxnSpPr/>
            <p:nvPr/>
          </p:nvCxnSpPr>
          <p:spPr bwMode="auto">
            <a:xfrm>
              <a:off x="8908583" y="3350346"/>
              <a:ext cx="703431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89" name="TextBox 188"/>
            <p:cNvSpPr txBox="1"/>
            <p:nvPr/>
          </p:nvSpPr>
          <p:spPr>
            <a:xfrm>
              <a:off x="8333468" y="3348751"/>
              <a:ext cx="1439281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/>
                <a:t>Oligomycin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8394785" y="1566857"/>
              <a:ext cx="1210945" cy="398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600" b="1" dirty="0"/>
                <a:t>MFI, CD83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10125034" y="1288462"/>
              <a:ext cx="1758951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Dendritic</a:t>
              </a:r>
              <a:r>
                <a:rPr lang="sv-SE" sz="700" b="1" dirty="0"/>
                <a:t> Cells 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11164687" y="1997980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11160905" y="2488942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7335880" y="1990620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7345838" y="2412327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7325428" y="2785008"/>
              <a:ext cx="930196" cy="434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7345332" y="4028687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7355288" y="4450397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11158331" y="4038873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chemeClr val="bg1">
                      <a:lumMod val="50000"/>
                    </a:schemeClr>
                  </a:solidFill>
                </a:rPr>
                <a:t>esiGFP</a:t>
              </a:r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  <a:p>
              <a:endParaRPr lang="sv-SE" sz="443" b="1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11153772" y="4460581"/>
              <a:ext cx="930196" cy="619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 err="1">
                  <a:solidFill>
                    <a:srgbClr val="92D050"/>
                  </a:solidFill>
                </a:rPr>
                <a:t>esiGFP</a:t>
              </a:r>
              <a:endParaRPr lang="sv-SE" sz="443" b="1" dirty="0">
                <a:solidFill>
                  <a:srgbClr val="92D050"/>
                </a:solidFill>
              </a:endParaRPr>
            </a:p>
            <a:p>
              <a:endParaRPr lang="sv-SE" sz="443" b="1" dirty="0">
                <a:solidFill>
                  <a:srgbClr val="92D050"/>
                </a:solidFill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 rot="16200000">
              <a:off x="9547972" y="2699118"/>
              <a:ext cx="869201" cy="5114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CCCP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 rot="16200000">
              <a:off x="5425245" y="2490458"/>
              <a:ext cx="1478196" cy="511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Oligomycin</a:t>
              </a:r>
              <a:r>
                <a:rPr lang="sv-SE" sz="800" dirty="0"/>
                <a:t> </a:t>
              </a:r>
            </a:p>
          </p:txBody>
        </p:sp>
        <p:cxnSp>
          <p:nvCxnSpPr>
            <p:cNvPr id="203" name="Straight Connector 202"/>
            <p:cNvCxnSpPr/>
            <p:nvPr/>
          </p:nvCxnSpPr>
          <p:spPr bwMode="auto">
            <a:xfrm>
              <a:off x="10150718" y="2688593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204" name="Straight Connector 203"/>
            <p:cNvCxnSpPr/>
            <p:nvPr/>
          </p:nvCxnSpPr>
          <p:spPr bwMode="auto">
            <a:xfrm>
              <a:off x="6351986" y="2614700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05" name="TextBox 204"/>
            <p:cNvSpPr txBox="1"/>
            <p:nvPr/>
          </p:nvSpPr>
          <p:spPr>
            <a:xfrm>
              <a:off x="5959956" y="1154203"/>
              <a:ext cx="370614" cy="6190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885" b="1" dirty="0"/>
                <a:t>I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9843906" y="1172850"/>
              <a:ext cx="370614" cy="6190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5" b="1" dirty="0"/>
                <a:t>J</a:t>
              </a:r>
              <a:endParaRPr lang="fi-FI" sz="885" b="1" dirty="0"/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1169506" y="2873871"/>
              <a:ext cx="930196" cy="434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11174762" y="4847687"/>
              <a:ext cx="930196" cy="434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7356057" y="4869628"/>
              <a:ext cx="930196" cy="434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443" b="1" dirty="0">
                  <a:solidFill>
                    <a:srgbClr val="FF0000"/>
                  </a:solidFill>
                </a:rPr>
                <a:t>esiPRC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 rot="16200000">
              <a:off x="9535268" y="4680318"/>
              <a:ext cx="869201" cy="5114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CCCP</a:t>
              </a:r>
            </a:p>
          </p:txBody>
        </p:sp>
        <p:cxnSp>
          <p:nvCxnSpPr>
            <p:cNvPr id="211" name="Straight Connector 210"/>
            <p:cNvCxnSpPr/>
            <p:nvPr/>
          </p:nvCxnSpPr>
          <p:spPr bwMode="auto">
            <a:xfrm>
              <a:off x="10138018" y="4669793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12" name="TextBox 211"/>
            <p:cNvSpPr txBox="1"/>
            <p:nvPr/>
          </p:nvSpPr>
          <p:spPr>
            <a:xfrm rot="16200000">
              <a:off x="5425238" y="4571707"/>
              <a:ext cx="1478196" cy="5114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Oligomycin</a:t>
              </a:r>
              <a:r>
                <a:rPr lang="sv-SE" sz="800" dirty="0"/>
                <a:t> </a:t>
              </a:r>
            </a:p>
          </p:txBody>
        </p:sp>
        <p:cxnSp>
          <p:nvCxnSpPr>
            <p:cNvPr id="213" name="Straight Connector 212"/>
            <p:cNvCxnSpPr/>
            <p:nvPr/>
          </p:nvCxnSpPr>
          <p:spPr bwMode="auto">
            <a:xfrm>
              <a:off x="6351986" y="4695955"/>
              <a:ext cx="2264" cy="518662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14" name="TextBox 213"/>
            <p:cNvSpPr txBox="1"/>
            <p:nvPr/>
          </p:nvSpPr>
          <p:spPr>
            <a:xfrm>
              <a:off x="6330496" y="1310250"/>
              <a:ext cx="1758951" cy="431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Dendritic</a:t>
              </a:r>
              <a:r>
                <a:rPr lang="sv-SE" sz="700" b="1" dirty="0"/>
                <a:t> Cells 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6339268" y="3214652"/>
              <a:ext cx="1481142" cy="4982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00" b="1" dirty="0" err="1"/>
                <a:t>Monocytes</a:t>
              </a:r>
              <a:r>
                <a:rPr lang="sv-SE" sz="900" b="1" dirty="0"/>
                <a:t> </a:t>
              </a:r>
            </a:p>
          </p:txBody>
        </p:sp>
      </p:grpSp>
      <p:sp>
        <p:nvSpPr>
          <p:cNvPr id="217" name="TextBox 216"/>
          <p:cNvSpPr txBox="1"/>
          <p:nvPr/>
        </p:nvSpPr>
        <p:spPr>
          <a:xfrm>
            <a:off x="13565" y="72418"/>
            <a:ext cx="2403030" cy="4122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079" dirty="0"/>
              <a:t>Supplemnetary Fig.3</a:t>
            </a:r>
          </a:p>
        </p:txBody>
      </p:sp>
      <p:grpSp>
        <p:nvGrpSpPr>
          <p:cNvPr id="218" name="Group 217"/>
          <p:cNvGrpSpPr/>
          <p:nvPr/>
        </p:nvGrpSpPr>
        <p:grpSpPr>
          <a:xfrm>
            <a:off x="2010844" y="4423724"/>
            <a:ext cx="4608875" cy="1720585"/>
            <a:chOff x="677011" y="-75583"/>
            <a:chExt cx="9707327" cy="3891230"/>
          </a:xfrm>
        </p:grpSpPr>
        <p:grpSp>
          <p:nvGrpSpPr>
            <p:cNvPr id="219" name="Group 218"/>
            <p:cNvGrpSpPr/>
            <p:nvPr/>
          </p:nvGrpSpPr>
          <p:grpSpPr>
            <a:xfrm>
              <a:off x="768916" y="209603"/>
              <a:ext cx="9615422" cy="3250886"/>
              <a:chOff x="768916" y="209603"/>
              <a:chExt cx="9615422" cy="3250886"/>
            </a:xfrm>
          </p:grpSpPr>
          <p:pic>
            <p:nvPicPr>
              <p:cNvPr id="226" name="Picture 225"/>
              <p:cNvPicPr>
                <a:picLocks noChangeAspect="1"/>
              </p:cNvPicPr>
              <p:nvPr/>
            </p:nvPicPr>
            <p:blipFill>
              <a:blip r:embed="rId41"/>
              <a:stretch>
                <a:fillRect/>
              </a:stretch>
            </p:blipFill>
            <p:spPr>
              <a:xfrm>
                <a:off x="7392909" y="220488"/>
                <a:ext cx="2991429" cy="3240001"/>
              </a:xfrm>
              <a:prstGeom prst="rect">
                <a:avLst/>
              </a:prstGeom>
            </p:spPr>
          </p:pic>
          <p:pic>
            <p:nvPicPr>
              <p:cNvPr id="227" name="Picture 226"/>
              <p:cNvPicPr>
                <a:picLocks noChangeAspect="1"/>
              </p:cNvPicPr>
              <p:nvPr/>
            </p:nvPicPr>
            <p:blipFill>
              <a:blip r:embed="rId42"/>
              <a:stretch>
                <a:fillRect/>
              </a:stretch>
            </p:blipFill>
            <p:spPr>
              <a:xfrm>
                <a:off x="4207660" y="209603"/>
                <a:ext cx="2991429" cy="3240000"/>
              </a:xfrm>
              <a:prstGeom prst="rect">
                <a:avLst/>
              </a:prstGeom>
            </p:spPr>
          </p:pic>
          <p:pic>
            <p:nvPicPr>
              <p:cNvPr id="228" name="Picture 227"/>
              <p:cNvPicPr>
                <a:picLocks noChangeAspect="1"/>
              </p:cNvPicPr>
              <p:nvPr/>
            </p:nvPicPr>
            <p:blipFill>
              <a:blip r:embed="rId43"/>
              <a:stretch>
                <a:fillRect/>
              </a:stretch>
            </p:blipFill>
            <p:spPr>
              <a:xfrm>
                <a:off x="813990" y="210213"/>
                <a:ext cx="3051429" cy="3240000"/>
              </a:xfrm>
              <a:prstGeom prst="rect">
                <a:avLst/>
              </a:prstGeom>
            </p:spPr>
          </p:pic>
          <p:sp>
            <p:nvSpPr>
              <p:cNvPr id="229" name="TextBox 228"/>
              <p:cNvSpPr txBox="1"/>
              <p:nvPr/>
            </p:nvSpPr>
            <p:spPr>
              <a:xfrm>
                <a:off x="9647003" y="860757"/>
                <a:ext cx="731627" cy="7683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50" dirty="0"/>
                  <a:t>DC</a:t>
                </a: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7979756" y="860757"/>
                <a:ext cx="1733298" cy="7683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50" dirty="0" err="1"/>
                  <a:t>Monocytes</a:t>
                </a:r>
                <a:endParaRPr lang="sv-SE" sz="1050" dirty="0"/>
              </a:p>
            </p:txBody>
          </p:sp>
          <p:cxnSp>
            <p:nvCxnSpPr>
              <p:cNvPr id="231" name="Straight Arrow Connector 230"/>
              <p:cNvCxnSpPr/>
              <p:nvPr/>
            </p:nvCxnSpPr>
            <p:spPr>
              <a:xfrm>
                <a:off x="6353436" y="2166259"/>
                <a:ext cx="1018917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Arrow Connector 231"/>
              <p:cNvCxnSpPr/>
              <p:nvPr/>
            </p:nvCxnSpPr>
            <p:spPr>
              <a:xfrm>
                <a:off x="3560705" y="2166258"/>
                <a:ext cx="1018918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Rectangle 232"/>
              <p:cNvSpPr/>
              <p:nvPr/>
            </p:nvSpPr>
            <p:spPr>
              <a:xfrm>
                <a:off x="2086882" y="3047337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  <p:sp>
            <p:nvSpPr>
              <p:cNvPr id="234" name="Rectangle 233"/>
              <p:cNvSpPr/>
              <p:nvPr/>
            </p:nvSpPr>
            <p:spPr>
              <a:xfrm>
                <a:off x="5439076" y="3047337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  <p:sp>
            <p:nvSpPr>
              <p:cNvPr id="235" name="Rectangle 234"/>
              <p:cNvSpPr/>
              <p:nvPr/>
            </p:nvSpPr>
            <p:spPr>
              <a:xfrm>
                <a:off x="8738534" y="3039514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  <p:sp>
            <p:nvSpPr>
              <p:cNvPr id="236" name="Rectangle 235"/>
              <p:cNvSpPr/>
              <p:nvPr/>
            </p:nvSpPr>
            <p:spPr>
              <a:xfrm rot="16200000">
                <a:off x="545759" y="1371006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  <p:sp>
            <p:nvSpPr>
              <p:cNvPr id="237" name="Rectangle 236"/>
              <p:cNvSpPr/>
              <p:nvPr/>
            </p:nvSpPr>
            <p:spPr>
              <a:xfrm rot="16200000">
                <a:off x="3907331" y="1458191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  <p:sp>
            <p:nvSpPr>
              <p:cNvPr id="238" name="Rectangle 237"/>
              <p:cNvSpPr/>
              <p:nvPr/>
            </p:nvSpPr>
            <p:spPr>
              <a:xfrm rot="16200000">
                <a:off x="7137173" y="1441787"/>
                <a:ext cx="794657" cy="3483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 sz="1050"/>
              </a:p>
            </p:txBody>
          </p:sp>
        </p:grpSp>
        <p:sp>
          <p:nvSpPr>
            <p:cNvPr id="220" name="TextBox 219"/>
            <p:cNvSpPr txBox="1"/>
            <p:nvPr/>
          </p:nvSpPr>
          <p:spPr>
            <a:xfrm>
              <a:off x="2182091" y="3036843"/>
              <a:ext cx="1083565" cy="76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/>
                <a:t>FSC-A</a:t>
              </a:r>
            </a:p>
          </p:txBody>
        </p:sp>
        <p:sp>
          <p:nvSpPr>
            <p:cNvPr id="221" name="TextBox 220"/>
            <p:cNvSpPr txBox="1"/>
            <p:nvPr/>
          </p:nvSpPr>
          <p:spPr>
            <a:xfrm rot="16200000">
              <a:off x="199432" y="1278321"/>
              <a:ext cx="1507429" cy="552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 err="1"/>
                <a:t>SSC</a:t>
              </a:r>
              <a:r>
                <a:rPr lang="sv-SE" sz="1050" dirty="0"/>
                <a:t>-A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5481470" y="3039903"/>
              <a:ext cx="1174933" cy="76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/>
                <a:t>FSC-W</a:t>
              </a:r>
            </a:p>
          </p:txBody>
        </p:sp>
        <p:sp>
          <p:nvSpPr>
            <p:cNvPr id="223" name="TextBox 222"/>
            <p:cNvSpPr txBox="1"/>
            <p:nvPr/>
          </p:nvSpPr>
          <p:spPr>
            <a:xfrm rot="16200000">
              <a:off x="3247560" y="769202"/>
              <a:ext cx="2241842" cy="5522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/>
                <a:t>Live/</a:t>
              </a:r>
              <a:r>
                <a:rPr lang="sv-SE" sz="1050" dirty="0" err="1"/>
                <a:t>Dead</a:t>
              </a:r>
              <a:endParaRPr lang="sv-SE" sz="1050" dirty="0"/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8904648" y="3047339"/>
              <a:ext cx="1026035" cy="76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/>
                <a:t>CD1a</a:t>
              </a:r>
            </a:p>
          </p:txBody>
        </p:sp>
        <p:sp>
          <p:nvSpPr>
            <p:cNvPr id="225" name="TextBox 224"/>
            <p:cNvSpPr txBox="1"/>
            <p:nvPr/>
          </p:nvSpPr>
          <p:spPr>
            <a:xfrm rot="16200000">
              <a:off x="6835825" y="1294209"/>
              <a:ext cx="1441520" cy="552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50" dirty="0"/>
                <a:t>CD14</a:t>
              </a:r>
            </a:p>
          </p:txBody>
        </p:sp>
      </p:grpSp>
      <p:sp>
        <p:nvSpPr>
          <p:cNvPr id="239" name="TextBox 238"/>
          <p:cNvSpPr txBox="1"/>
          <p:nvPr/>
        </p:nvSpPr>
        <p:spPr>
          <a:xfrm>
            <a:off x="1822136" y="4489619"/>
            <a:ext cx="198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F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037B092F-7C85-4690-9357-8623AAF83C56}"/>
              </a:ext>
            </a:extLst>
          </p:cNvPr>
          <p:cNvSpPr txBox="1"/>
          <p:nvPr/>
        </p:nvSpPr>
        <p:spPr>
          <a:xfrm>
            <a:off x="7630184" y="916007"/>
            <a:ext cx="34977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00" b="1" dirty="0"/>
              <a:t>CD83</a:t>
            </a:r>
            <a:endParaRPr lang="sv-SE" sz="443" b="1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CE774CB-66E6-4FDC-A86C-A5D8DCA1C079}"/>
              </a:ext>
            </a:extLst>
          </p:cNvPr>
          <p:cNvSpPr txBox="1"/>
          <p:nvPr/>
        </p:nvSpPr>
        <p:spPr>
          <a:xfrm>
            <a:off x="4431746" y="1169664"/>
            <a:ext cx="471604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 err="1"/>
              <a:t>Vinculin</a:t>
            </a:r>
            <a:r>
              <a:rPr lang="sv-SE" sz="625" b="1" dirty="0"/>
              <a:t> 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7A24FE9B-3091-45A0-AE5D-ECE4978E4E8C}"/>
              </a:ext>
            </a:extLst>
          </p:cNvPr>
          <p:cNvSpPr txBox="1"/>
          <p:nvPr/>
        </p:nvSpPr>
        <p:spPr>
          <a:xfrm>
            <a:off x="4544142" y="1042482"/>
            <a:ext cx="332142" cy="188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625" b="1" dirty="0"/>
              <a:t>PRC </a:t>
            </a:r>
          </a:p>
        </p:txBody>
      </p:sp>
    </p:spTree>
    <p:extLst>
      <p:ext uri="{BB962C8B-B14F-4D97-AF65-F5344CB8AC3E}">
        <p14:creationId xmlns:p14="http://schemas.microsoft.com/office/powerpoint/2010/main" val="360153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7</TotalTime>
  <Words>145</Words>
  <Application>Microsoft Office PowerPoint</Application>
  <PresentationFormat>Widescreen</PresentationFormat>
  <Paragraphs>9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ler, Marcin (L&amp;W, Black Mountain)</dc:creator>
  <cp:lastModifiedBy>Buler, Marcin (L&amp;W, Black Mountain)</cp:lastModifiedBy>
  <cp:revision>15</cp:revision>
  <dcterms:created xsi:type="dcterms:W3CDTF">2019-06-18T05:23:11Z</dcterms:created>
  <dcterms:modified xsi:type="dcterms:W3CDTF">2020-05-12T00:21:55Z</dcterms:modified>
</cp:coreProperties>
</file>